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904BF6-A819-4A2E-B848-480D7F6072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118D62-0A71-4A1A-AD40-22FF02C85E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4BE90C-36C6-47B4-A4C2-897191C4E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96ED15-0AC1-4242-8E63-6FDFBBAEC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BAA843-E1FA-48E6-AF57-B0F788546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3246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87871-1CA6-4BCA-BAEA-2BCABE779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AAB6FA-CE33-47CC-94DC-879F2EEA9B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7F0871-6756-44A7-BC33-33F8BDE35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4C3F0D-170C-4550-BE25-8DAFAE881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276914-D835-4BD8-947A-70671DAB4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3539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AD0A62-D893-46B4-81EB-140D27F09C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C6899F-9E64-4A0F-AEC8-5CB52FF40F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961483-F936-4C60-A23F-5DB9ECD33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786B68-E49B-401E-AE60-850186BF2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841331-FFFA-4359-BBEE-6360BDE19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267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09D62-4C4E-4822-A08A-C969ADFFE2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A126E9-375C-4BA3-921D-B00CA9EAD5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DFCC24-AA79-4918-B86E-26095AEF7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544328-0AF0-4576-9000-F5EB5B583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FA7CE3-1CFC-4066-88B3-FEEBE26C6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8325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A7F325-3450-45A6-9330-0AFB34B29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B3DEEC-E1E2-44E5-903F-3BAFB2EEFF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174284-1346-43B7-8FB9-7C7CDB7E2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7D1CBE-04E5-4E51-B228-BD45AE10F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FE3D5A-DB05-4845-8BF6-7817A5330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29584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43AAA-60A2-45CC-8C83-A0CA152E8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F91E6A-EBD8-4DB3-88E4-8B3BCC6949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0EE128-5FD3-488C-984C-747F6071CE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711688-7E7E-4AC6-9101-8F90F203A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EB6E7E-5EAC-4AEF-98C2-DF8343DE06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C2FEA0-2613-4DAB-9279-CEE2414EE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3962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4EA4D-829F-4E81-A5A8-A6336502C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FA1AAA-4600-40EF-8182-4F45AE6829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F55D85-4AF7-47B5-AE67-6D42907151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C7C0AB-5174-4666-85BD-6D63287F15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679369-EC4F-4DB8-8654-0A87E5DF69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E3DBD5-C21C-45EE-AB3C-77F90E834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AC67DF-B49F-4C60-A901-6FE289E5B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E68FC8-D3DF-4988-8900-4028BF0FAD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34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5B48B4-5D5C-446D-A33A-2B3E2BEBB3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E62D3E-FEAB-4A1B-A41F-1B845FCE9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9B88E9-3F84-4DC6-91F8-527AF9A80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F30E61-2474-4D95-9884-22F2CB1BF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04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C415A2-785B-4CBD-9DE9-D488FAE91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6DE1CD-50E2-44B5-BF3F-4E2B80BDB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6C094F0-9246-4236-A349-2E90CB417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9689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E691DF-99B1-471F-AECB-BC3E40B3EA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D6C10C-D663-4213-88E8-8A3BD74063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638C61-C1E1-4DB8-A049-3E972BAEB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46EBE7-0DB4-458C-B57B-53B20CAF8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EACAC8-83BF-40FF-941A-F63F8B35D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684580-C8FC-4E74-B4F1-2609CE9A9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0452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265225-AB1F-455B-8052-4C18D5D1B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39C985-DF5A-4696-B7C1-1797F0E674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89ED72-D362-489C-929C-2D56339617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759D2C-97E4-4613-9EFB-57422FF59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6BDAEA-C7E3-4100-83C4-71C0DA572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CB328D-8BE9-4A2E-B0A1-AA96121F0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2678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9CD7135-D4B0-4D31-99CC-A76A149C96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43F8E7-C1EB-4658-8F99-36A0CB08F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E46-4F47-4B29-91E8-36AC79CBA9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F4F4D-C2F2-4F10-8795-C7533DE16B97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075C6-0D1E-4FC9-BB8F-A2FAFAE042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FE36F7-4D92-4413-ADD5-4E8659DFE4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A2473-1490-42CD-97F9-89AFD8CA4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7402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96F460B-2ED4-419A-B332-848501AA5A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196" y="110693"/>
            <a:ext cx="11430000" cy="199048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60ADDFF-A3B8-435D-9218-672E8601EBA2}"/>
              </a:ext>
            </a:extLst>
          </p:cNvPr>
          <p:cNvSpPr/>
          <p:nvPr/>
        </p:nvSpPr>
        <p:spPr>
          <a:xfrm>
            <a:off x="5265946" y="423390"/>
            <a:ext cx="13553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Abscisic acid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8256AB6-5445-4522-991C-5846155B68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2374" y="2163545"/>
            <a:ext cx="11644009" cy="180534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BAC5A612-FBA1-4D94-B9B4-F3CFEE432991}"/>
              </a:ext>
            </a:extLst>
          </p:cNvPr>
          <p:cNvSpPr/>
          <p:nvPr/>
        </p:nvSpPr>
        <p:spPr>
          <a:xfrm>
            <a:off x="5502424" y="2277549"/>
            <a:ext cx="7136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Auxi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D953182-7485-40F4-AA21-87C80147DF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004" y="4127998"/>
            <a:ext cx="11673192" cy="2433149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CF0EAABE-CAD0-417E-A403-7C52D7D408E2}"/>
              </a:ext>
            </a:extLst>
          </p:cNvPr>
          <p:cNvSpPr/>
          <p:nvPr/>
        </p:nvSpPr>
        <p:spPr>
          <a:xfrm>
            <a:off x="4954332" y="4451660"/>
            <a:ext cx="16218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err="1"/>
              <a:t>Brassinosteroid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32834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640E809-99B6-40A2-AA35-8BBF1208C7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285" y="1"/>
            <a:ext cx="11569430" cy="2130457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D4D49E8-DD2A-4CA7-B707-64E347F39C5D}"/>
              </a:ext>
            </a:extLst>
          </p:cNvPr>
          <p:cNvSpPr/>
          <p:nvPr/>
        </p:nvSpPr>
        <p:spPr>
          <a:xfrm>
            <a:off x="5408544" y="248215"/>
            <a:ext cx="106362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Cytokini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3B5B95F-24AE-4971-A3FA-5CEC7B0FB6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198535"/>
            <a:ext cx="12192000" cy="246093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6607ADDC-8D86-4D2D-90E5-EAF2B53F1137}"/>
              </a:ext>
            </a:extLst>
          </p:cNvPr>
          <p:cNvSpPr/>
          <p:nvPr/>
        </p:nvSpPr>
        <p:spPr>
          <a:xfrm>
            <a:off x="5408544" y="2350590"/>
            <a:ext cx="12155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Gibberellin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2C91080-37E5-452D-8218-959E86F96B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9289" y="4550263"/>
            <a:ext cx="12192000" cy="2506521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7B883A38-EC1F-4A63-983F-C5A65034E6E5}"/>
              </a:ext>
            </a:extLst>
          </p:cNvPr>
          <p:cNvSpPr/>
          <p:nvPr/>
        </p:nvSpPr>
        <p:spPr>
          <a:xfrm>
            <a:off x="5203616" y="5075238"/>
            <a:ext cx="14734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err="1"/>
              <a:t>Jasmonic</a:t>
            </a:r>
            <a:r>
              <a:rPr lang="en-GB" dirty="0"/>
              <a:t> acid</a:t>
            </a:r>
          </a:p>
        </p:txBody>
      </p:sp>
    </p:spTree>
    <p:extLst>
      <p:ext uri="{BB962C8B-B14F-4D97-AF65-F5344CB8AC3E}">
        <p14:creationId xmlns:p14="http://schemas.microsoft.com/office/powerpoint/2010/main" val="25755382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D9FC31C-D518-44B7-9B4A-1D9A53CF4F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3478"/>
            <a:ext cx="12192000" cy="213334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91F54D6F-9008-4F5F-BCF9-A1A42EA8D3F1}"/>
              </a:ext>
            </a:extLst>
          </p:cNvPr>
          <p:cNvSpPr/>
          <p:nvPr/>
        </p:nvSpPr>
        <p:spPr>
          <a:xfrm>
            <a:off x="5091037" y="0"/>
            <a:ext cx="13484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Salicylic acid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86980E5-2DB4-4E28-9B64-8AD33ADCA9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277" y="2554172"/>
            <a:ext cx="12094723" cy="1749655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C8DE78CB-48EB-4B50-AE94-AA3CB10B101A}"/>
              </a:ext>
            </a:extLst>
          </p:cNvPr>
          <p:cNvSpPr/>
          <p:nvPr/>
        </p:nvSpPr>
        <p:spPr>
          <a:xfrm>
            <a:off x="5266052" y="2475849"/>
            <a:ext cx="9984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Ethylene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7B80CB7-56C0-4249-9F5F-15351DAF22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131" y="4382150"/>
            <a:ext cx="11997459" cy="2495795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6B2A8F96-9B4D-4775-94C0-3DEA59C2433C}"/>
              </a:ext>
            </a:extLst>
          </p:cNvPr>
          <p:cNvSpPr/>
          <p:nvPr/>
        </p:nvSpPr>
        <p:spPr>
          <a:xfrm>
            <a:off x="5480756" y="4601181"/>
            <a:ext cx="15145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Strigolactones</a:t>
            </a:r>
          </a:p>
        </p:txBody>
      </p:sp>
    </p:spTree>
    <p:extLst>
      <p:ext uri="{BB962C8B-B14F-4D97-AF65-F5344CB8AC3E}">
        <p14:creationId xmlns:p14="http://schemas.microsoft.com/office/powerpoint/2010/main" val="3901529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2</Words>
  <Application>Microsoft Office PowerPoint</Application>
  <PresentationFormat>Widescreen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HP</cp:lastModifiedBy>
  <cp:revision>14</cp:revision>
  <dcterms:created xsi:type="dcterms:W3CDTF">2019-10-20T12:04:49Z</dcterms:created>
  <dcterms:modified xsi:type="dcterms:W3CDTF">2020-08-20T07:23:52Z</dcterms:modified>
</cp:coreProperties>
</file>